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83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654D5F-59B7-9177-FE13-1A68BEECF02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6ECD6D0-8B87-1036-90C7-03B31F81E0F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7B206A-1A9D-F00B-BAB9-301722C0AE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D769C-ADF5-44C4-9739-91C80A249FEF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A7F754-F113-65AB-CA4B-EAF14CA8F5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A6D42F-5D00-A123-3D4A-CF6A2D077A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264CBC-4F75-4A5F-BEBB-8DB52E344C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93820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13BEE6-B372-21BD-03B8-2D45DB2ED1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B520F94-7967-4982-E0E5-EE47EB659DD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FB9484-BFC1-BCD8-61F9-2763053042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D769C-ADF5-44C4-9739-91C80A249FEF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9F5E3F-EBA2-CB45-F4ED-FB29A07245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03696E-E90C-7883-4860-0DFE341320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264CBC-4F75-4A5F-BEBB-8DB52E344C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10314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208DCCC-8C90-33B6-FFCD-DF91737E82D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F8FDEBC-CFD3-3D13-F163-C4552454369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DFDC05-5557-F8BC-C33D-6653420B27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D769C-ADF5-44C4-9739-91C80A249FEF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00E3B6-245B-3C58-EF32-936BED424A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DE0EFD-EE79-7969-117F-9D6F01A649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264CBC-4F75-4A5F-BEBB-8DB52E344C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18594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F40946-6A1D-967F-3DB8-C59040B341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2D0E922-EA12-26C6-94CD-5DD3B21382F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15A5856-971A-4E10-03C0-F02C037FCF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D769C-ADF5-44C4-9739-91C80A249FEF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C9D803-4152-D2FA-47F9-41E99A7008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E4E345-709F-330C-1E93-681302546C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264CBC-4F75-4A5F-BEBB-8DB52E344C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01423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EC5CAE-746B-1CFC-CDC7-F6B98E5636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12B02F6-108B-8501-B18E-B40C20E6C7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4B1C12-04F7-6E04-4E23-E2AD27572D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D769C-ADF5-44C4-9739-91C80A249FEF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51597D-1C7A-C7BB-96A3-87E3286975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AAB191-EFD4-85C8-82F4-71F29369EA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264CBC-4F75-4A5F-BEBB-8DB52E344C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61522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D4AE79-F52C-9950-9B81-5572609205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9D12DCD-46B6-F753-DBDA-EE92021A99F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4AED007-E930-37B9-BDAF-B9E7600BDD1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0AC66F3-594E-39C7-4449-B28F990D3B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D769C-ADF5-44C4-9739-91C80A249FEF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16759B6-086B-998E-563A-D68E23CF04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640A78A-98B1-7C0A-CDF2-F35051FAB8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264CBC-4F75-4A5F-BEBB-8DB52E344C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48876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1FE26F-B6ED-587E-67DA-3A384822A3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53986BE-F625-F168-2E1B-CF1134C852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8972F84-7472-5286-F119-4E73D1865FF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F4AB823-2F35-C1BA-EB9D-F72AE1D622E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B461A0E-92E2-1F1C-912E-58439DE6E4F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D0E26EF-24CD-4475-F4DF-BAE2D99BA2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D769C-ADF5-44C4-9739-91C80A249FEF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2234865-05FB-A81E-3C77-01CA305C5C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7255819-351F-1018-4BE0-24687B9BC6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264CBC-4F75-4A5F-BEBB-8DB52E344C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3581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05BDF4-DEB9-13F0-3B13-9851EE3C2B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87E48D3-B645-886F-914E-4C1A5B7729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D769C-ADF5-44C4-9739-91C80A249FEF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B7B27AE-540E-799F-F331-F626C38AD5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67350CD-9DCA-740A-F96B-A0BCE5A17F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264CBC-4F75-4A5F-BEBB-8DB52E344C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60530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1951AE0-B766-F79F-F874-6F2B112BDC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D769C-ADF5-44C4-9739-91C80A249FEF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DA6C375-23BC-6E96-A8AB-6088EC6636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E98CE5F-EF7A-6B1E-6642-C203220AB5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264CBC-4F75-4A5F-BEBB-8DB52E344C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01113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7E4A26-E370-05B6-1544-F3077C3867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0A4F678-0CEC-A149-4D28-D545D9E5BA2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07F7138-EA90-F5D2-47A6-831AF44D393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C60F0B3-F832-E36F-C257-E5C82753F7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D769C-ADF5-44C4-9739-91C80A249FEF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93D4B0B-FBF4-286D-6143-2AE0FC71FE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A418BDF-5D5B-FAAD-AFD0-61A8DF70EB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264CBC-4F75-4A5F-BEBB-8DB52E344C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2046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AE6CE5-8A31-EE87-01D4-E09A8422B6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7891C8A-350C-AA5B-92F4-CC7446E07A2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D539341-1033-F984-7591-02AEF6C71CF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079F2E9-7FD3-1C7F-861A-12A8D9762E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D769C-ADF5-44C4-9739-91C80A249FEF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FDD90CE-2C51-CA7B-F997-3FD11628F3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09FF8EC-30D4-0760-1DD8-53C015F571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264CBC-4F75-4A5F-BEBB-8DB52E344C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77222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36AE943-E3C3-70C6-4D74-9396327D79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FC41E59-C408-3C60-C2AF-DDB4A0D21E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9EF06A-FE4F-407F-DF4F-6F8EA36E31D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CED769C-ADF5-44C4-9739-91C80A249FEF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447607-B544-634A-CF10-57B0D493760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81EF99-B0E4-11BF-ADC7-C0264050925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6264CBC-4F75-4A5F-BEBB-8DB52E344C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28769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/>
        </p:nvGraphicFramePr>
        <p:xfrm>
          <a:off x="1527718" y="1812258"/>
          <a:ext cx="8261175" cy="151384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028114">
                  <a:extLst>
                    <a:ext uri="{9D8B030D-6E8A-4147-A177-3AD203B41FA5}">
                      <a16:colId xmlns:a16="http://schemas.microsoft.com/office/drawing/2014/main" val="2455828994"/>
                    </a:ext>
                  </a:extLst>
                </a:gridCol>
                <a:gridCol w="1174282">
                  <a:extLst>
                    <a:ext uri="{9D8B030D-6E8A-4147-A177-3AD203B41FA5}">
                      <a16:colId xmlns:a16="http://schemas.microsoft.com/office/drawing/2014/main" val="25198421"/>
                    </a:ext>
                  </a:extLst>
                </a:gridCol>
                <a:gridCol w="1058779">
                  <a:extLst>
                    <a:ext uri="{9D8B030D-6E8A-4147-A177-3AD203B41FA5}">
                      <a16:colId xmlns:a16="http://schemas.microsoft.com/office/drawing/2014/main" val="3650132125"/>
                    </a:ext>
                  </a:extLst>
                </a:gridCol>
              </a:tblGrid>
              <a:tr h="184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ynapse</a:t>
                      </a:r>
                      <a:r>
                        <a:rPr lang="en-US" sz="1200" b="1" u="none" strike="noStrike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functions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-valu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17521321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aintenance of Synapse Structure (GO:0099558) 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673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697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93592697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resynaptic Dense Core Vesicle Exocytosis (GO:0099525) 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342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697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73836615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Neuronal Dense </a:t>
                      </a:r>
                      <a:r>
                        <a:rPr lang="fr-FR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re</a:t>
                      </a:r>
                      <a:r>
                        <a:rPr lang="fr-FR" sz="1200" u="none" strike="noStrike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sicle</a:t>
                      </a:r>
                      <a:r>
                        <a:rPr lang="fr-FR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GO:0098992) 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453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241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71453397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ynaptic Vesicle Endocytosis (GO:0048488) 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974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241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27694268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ynapse (GO:0045202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979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241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34510924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egulation of Postsynaptic Membrane Neurotransmitter Receptor Levels (GO:0099072) 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492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241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47805961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ostsynaptic Density, Intracellular Component (GO:0099092) 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521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521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74509740"/>
                  </a:ext>
                </a:extLst>
              </a:tr>
            </a:tbl>
          </a:graphicData>
        </a:graphic>
      </p:graphicFrame>
      <p:sp>
        <p:nvSpPr>
          <p:cNvPr id="3" name="Rectangle 2"/>
          <p:cNvSpPr/>
          <p:nvPr/>
        </p:nvSpPr>
        <p:spPr>
          <a:xfrm>
            <a:off x="1441265" y="1551987"/>
            <a:ext cx="732359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S10 Table. Analysis of down-regulated proteins by </a:t>
            </a:r>
            <a:r>
              <a:rPr lang="en-US" sz="1200" b="1" dirty="0" err="1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SynGo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5136833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0</Words>
  <Application>Microsoft Office PowerPoint</Application>
  <PresentationFormat>Widescreen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ang, Yuyang</dc:creator>
  <cp:lastModifiedBy>Tang, Yuyang</cp:lastModifiedBy>
  <cp:revision>1</cp:revision>
  <dcterms:created xsi:type="dcterms:W3CDTF">2025-07-28T20:05:07Z</dcterms:created>
  <dcterms:modified xsi:type="dcterms:W3CDTF">2025-07-28T20:05:38Z</dcterms:modified>
</cp:coreProperties>
</file>